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3" r:id="rId2"/>
    <p:sldId id="276" r:id="rId3"/>
    <p:sldId id="275" r:id="rId4"/>
    <p:sldId id="265" r:id="rId5"/>
    <p:sldId id="267" r:id="rId6"/>
    <p:sldId id="268" r:id="rId7"/>
    <p:sldId id="269" r:id="rId8"/>
    <p:sldId id="257" r:id="rId9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uchan" initials="B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1DDC1"/>
    <a:srgbClr val="EDC3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296" autoAdjust="0"/>
    <p:restoredTop sz="94660"/>
  </p:normalViewPr>
  <p:slideViewPr>
    <p:cSldViewPr snapToGrid="0">
      <p:cViewPr varScale="1">
        <p:scale>
          <a:sx n="62" d="100"/>
          <a:sy n="62" d="100"/>
        </p:scale>
        <p:origin x="932" y="4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7D1000-6CAC-4F2E-84AC-3060EF2E4A27}" type="datetimeFigureOut">
              <a:rPr kumimoji="1" lang="ja-JP" altLang="en-US" smtClean="0"/>
              <a:pPr/>
              <a:t>2026/3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C5B800-BFDA-4C8F-A5A2-77D08B874B8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66171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BC5B800-BFDA-4C8F-A5A2-77D08B874B89}" type="slidenum">
              <a:rPr kumimoji="1" lang="ja-JP" altLang="en-US" smtClean="0"/>
              <a:pPr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44961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136852-7F57-1C90-7E70-CA8839B626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C043D8C-762F-703C-FA70-0DFB9765AC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BF9FA75-1328-6098-075B-EC3D92E8F2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838F-9604-4994-B5E9-2DEA727DA952}" type="datetimeFigureOut">
              <a:rPr kumimoji="1" lang="ja-JP" altLang="en-US" smtClean="0"/>
              <a:pPr/>
              <a:t>2026/3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A433D2-ED75-F6DB-16C3-A5E232F724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72B2CD6-C333-DCD8-2125-B8D38D9F5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3BE9E-5BE3-47E2-8EA1-FCCF2932023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7483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C5DD08-826A-B7DB-F0FF-58717B3B83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C99D52F-F3E1-BE04-E7EB-6139C95E9A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10EFCE8-1E3B-C97C-A4AB-0C429D4058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838F-9604-4994-B5E9-2DEA727DA952}" type="datetimeFigureOut">
              <a:rPr kumimoji="1" lang="ja-JP" altLang="en-US" smtClean="0"/>
              <a:pPr/>
              <a:t>2026/3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339E900-10F8-DCAC-DFF7-052C51F27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93BD357-1D89-C97F-EB43-4E66E2A9D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3BE9E-5BE3-47E2-8EA1-FCCF2932023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9260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8EAC963-CEED-4E90-A91A-A215A9643D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DF260EA-BC7B-B7C3-273F-D41696CCAE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B4FFE9-1989-8031-A482-2496DEFF8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838F-9604-4994-B5E9-2DEA727DA952}" type="datetimeFigureOut">
              <a:rPr kumimoji="1" lang="ja-JP" altLang="en-US" smtClean="0"/>
              <a:pPr/>
              <a:t>2026/3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AA7BD7C-887F-50B0-C4AB-624555FC6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AE77263-4A0F-9635-0035-B70010ECF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3BE9E-5BE3-47E2-8EA1-FCCF2932023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2948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AA23D8-3321-A22D-588B-8A27A578B8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5966213-1C4D-6847-962C-F58DA01281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3596E35-E946-3099-EF1D-E23E1D52FF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838F-9604-4994-B5E9-2DEA727DA952}" type="datetimeFigureOut">
              <a:rPr kumimoji="1" lang="ja-JP" altLang="en-US" smtClean="0"/>
              <a:pPr/>
              <a:t>2026/3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CE99E6-5845-6780-3271-D4C660E9A0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305CFB6-0634-3A9E-F493-803680662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3BE9E-5BE3-47E2-8EA1-FCCF2932023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7407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11B7CE-5E9C-4826-5DDF-C09F2528B2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23E4CAF-E33C-51BF-10E1-BCAAFEBCC4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7E01D0-04BD-E21F-B53B-9B302E2CBD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838F-9604-4994-B5E9-2DEA727DA952}" type="datetimeFigureOut">
              <a:rPr kumimoji="1" lang="ja-JP" altLang="en-US" smtClean="0"/>
              <a:pPr/>
              <a:t>2026/3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2D5B420-58CE-F1CE-C851-A4C67135E8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9302EDF-5045-180F-223A-A0165556F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3BE9E-5BE3-47E2-8EA1-FCCF2932023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8083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38DC4A-306E-F3B4-5BE2-C5D3BFC9D5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EB37DDB-744F-BBA2-783F-F1CEED1F13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F8F69A9-9052-EABE-E04C-A3169DD7DF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CE2C46D-E346-DB18-36DB-7136155DC1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838F-9604-4994-B5E9-2DEA727DA952}" type="datetimeFigureOut">
              <a:rPr kumimoji="1" lang="ja-JP" altLang="en-US" smtClean="0"/>
              <a:pPr/>
              <a:t>2026/3/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E7AF15A-0C6F-68FC-8717-C6D2E96C67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25BF124-1D93-5A2A-4B96-09B2E6D1C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3BE9E-5BE3-47E2-8EA1-FCCF2932023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0820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6743A7-A34A-6FD4-ACB6-51CFC0910B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BF2587E-BFD6-BF32-2622-5A7C607CEE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427B109-0FCF-5CBD-4754-181A43AF5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DEA7B0C-E2E8-1C18-6159-6E4AF2BBE5C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FA59EDD-9B2D-02C1-AACF-8F397D1D99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B1790D8-4986-C509-375C-2C0BF99BED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838F-9604-4994-B5E9-2DEA727DA952}" type="datetimeFigureOut">
              <a:rPr kumimoji="1" lang="ja-JP" altLang="en-US" smtClean="0"/>
              <a:pPr/>
              <a:t>2026/3/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0424DF1-BB08-D78F-44A2-D788ACA9E5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8B41C2B-15FE-513D-7B92-3DDE2EF5F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3BE9E-5BE3-47E2-8EA1-FCCF2932023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2433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746B40-1399-1C34-276F-3F7C7F8B69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4464D0F-044A-A3C6-A5BE-DF4733043C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838F-9604-4994-B5E9-2DEA727DA952}" type="datetimeFigureOut">
              <a:rPr kumimoji="1" lang="ja-JP" altLang="en-US" smtClean="0"/>
              <a:pPr/>
              <a:t>2026/3/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B349120-1E63-1469-A950-20F8E04D8A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BE77EC1-DE1A-44FE-1251-9E72318A8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3BE9E-5BE3-47E2-8EA1-FCCF2932023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6279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FA1830F-3215-B993-EBC8-1BEAA496E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838F-9604-4994-B5E9-2DEA727DA952}" type="datetimeFigureOut">
              <a:rPr kumimoji="1" lang="ja-JP" altLang="en-US" smtClean="0"/>
              <a:pPr/>
              <a:t>2026/3/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FDE4F5D-517C-8178-C26D-FF3AA8FEB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0B2B69A-DC4A-2CF6-7141-CD4AEFCFA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3BE9E-5BE3-47E2-8EA1-FCCF2932023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1234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348355-F821-612E-D59B-94B51F617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FC6F710-05A6-99D7-772E-FEA3EE3F8C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ACF35A8-FCD8-DEC8-6007-2D180CA6EE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DFECA6D-B866-582B-A977-273F7B5772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838F-9604-4994-B5E9-2DEA727DA952}" type="datetimeFigureOut">
              <a:rPr kumimoji="1" lang="ja-JP" altLang="en-US" smtClean="0"/>
              <a:pPr/>
              <a:t>2026/3/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A73037E-D00A-8642-FD74-766CC33A87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F245E7-DAA2-B69D-4411-D8C26F0299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3BE9E-5BE3-47E2-8EA1-FCCF2932023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49557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72B85A-56D0-ED30-9235-456FA2589E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F968B3F-A75F-6EFC-4162-AF568278B3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8472FE3-2896-BEF4-90D4-257B9633EA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BEF2437-637C-FBA2-7FD2-58CEE98F9D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838F-9604-4994-B5E9-2DEA727DA952}" type="datetimeFigureOut">
              <a:rPr kumimoji="1" lang="ja-JP" altLang="en-US" smtClean="0"/>
              <a:pPr/>
              <a:t>2026/3/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C546853-9C2C-76E2-2200-A69CCA3631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2A5CB38-97BC-7F1E-F9CC-51EF92077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3BE9E-5BE3-47E2-8EA1-FCCF2932023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9105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E9CCB5E-6C2C-A27C-0D31-C761C0123B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6C5550C-7E54-BB0E-29D2-B44F86D5EA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7D47E3-F02A-18C9-D7C5-E12655A408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12838F-9604-4994-B5E9-2DEA727DA952}" type="datetimeFigureOut">
              <a:rPr kumimoji="1" lang="ja-JP" altLang="en-US" smtClean="0"/>
              <a:pPr/>
              <a:t>2026/3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9EFDB9-CAFE-5626-7FFC-983906C502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BAE77DC-9711-5718-C0FF-F15C4BD7C2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63BE9E-5BE3-47E2-8EA1-FCCF2932023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07591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B0F1B2C-85CA-292D-5221-701146A7C9D6}"/>
              </a:ext>
            </a:extLst>
          </p:cNvPr>
          <p:cNvSpPr txBox="1"/>
          <p:nvPr/>
        </p:nvSpPr>
        <p:spPr>
          <a:xfrm>
            <a:off x="1951893" y="4651537"/>
            <a:ext cx="84736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1. Product release testing for S‑ADSC spheroids.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 clinical lot met SOP acceptance criteria.</a:t>
            </a:r>
          </a:p>
          <a:p>
            <a:pPr algn="l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</a:t>
            </a:r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ays: sterility (aerobic/anaerobic culture), endotoxin (LAL assay), mycoplasma (culture/PCR), and pre‑releas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l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</a:t>
            </a:r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ability (automated counter).</a:t>
            </a:r>
          </a:p>
        </p:txBody>
      </p:sp>
      <p:pic>
        <p:nvPicPr>
          <p:cNvPr id="2" name="table">
            <a:extLst>
              <a:ext uri="{FF2B5EF4-FFF2-40B4-BE49-F238E27FC236}">
                <a16:creationId xmlns:a16="http://schemas.microsoft.com/office/drawing/2014/main" id="{FAECFAD4-E76B-F8AE-D6C8-11821E1CA21A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766505" y="1981732"/>
            <a:ext cx="4091440" cy="2036217"/>
          </a:xfrm>
          <a:prstGeom prst="rect">
            <a:avLst/>
          </a:prstGeom>
        </p:spPr>
      </p:pic>
      <p:pic>
        <p:nvPicPr>
          <p:cNvPr id="3" name="table">
            <a:extLst>
              <a:ext uri="{FF2B5EF4-FFF2-40B4-BE49-F238E27FC236}">
                <a16:creationId xmlns:a16="http://schemas.microsoft.com/office/drawing/2014/main" id="{949DF26D-24BA-8BD9-CB7C-89A989E02E34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334056" y="1981731"/>
            <a:ext cx="4091439" cy="14578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69568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CA079AF-2DE2-B99F-A9C7-916D84BB653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F9AAE1D-FA67-4966-4AC6-574671882935}"/>
              </a:ext>
            </a:extLst>
          </p:cNvPr>
          <p:cNvSpPr txBox="1"/>
          <p:nvPr/>
        </p:nvSpPr>
        <p:spPr>
          <a:xfrm>
            <a:off x="657545" y="5955570"/>
            <a:ext cx="71816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2. Full inclusion and exclusion criteria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</a:t>
            </a:r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licit exclusion: dual antiplatelet therapy (two or more antiplatelet agents).</a:t>
            </a: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02989B04-3ECD-5315-C924-03DBDECB4E6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6765379"/>
              </p:ext>
            </p:extLst>
          </p:nvPr>
        </p:nvGraphicFramePr>
        <p:xfrm>
          <a:off x="657545" y="440765"/>
          <a:ext cx="7798086" cy="5169790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3899043">
                  <a:extLst>
                    <a:ext uri="{9D8B030D-6E8A-4147-A177-3AD203B41FA5}">
                      <a16:colId xmlns:a16="http://schemas.microsoft.com/office/drawing/2014/main" val="2219556313"/>
                    </a:ext>
                  </a:extLst>
                </a:gridCol>
                <a:gridCol w="3899043">
                  <a:extLst>
                    <a:ext uri="{9D8B030D-6E8A-4147-A177-3AD203B41FA5}">
                      <a16:colId xmlns:a16="http://schemas.microsoft.com/office/drawing/2014/main" val="13213418"/>
                    </a:ext>
                  </a:extLst>
                </a:gridCol>
              </a:tblGrid>
              <a:tr h="13747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lusion criteria</a:t>
                      </a:r>
                      <a:endParaRPr lang="ja-JP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clusion criteria</a:t>
                      </a:r>
                      <a:endParaRPr lang="ja-JP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 anchor="ctr"/>
                </a:tc>
                <a:extLst>
                  <a:ext uri="{0D108BD9-81ED-4DB2-BD59-A6C34878D82A}">
                    <a16:rowId xmlns:a16="http://schemas.microsoft.com/office/drawing/2014/main" val="3110029279"/>
                  </a:ext>
                </a:extLst>
              </a:tr>
              <a:tr h="43633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≥ 20 years at consent.</a:t>
                      </a:r>
                      <a:endParaRPr lang="ja-JP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lammatory arthropathies (e.g., rheumatoid arthritis, psoriatic arthritis, gout/CPPD) or prior septic arthritis of the index knee.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extLst>
                  <a:ext uri="{0D108BD9-81ED-4DB2-BD59-A6C34878D82A}">
                    <a16:rowId xmlns:a16="http://schemas.microsoft.com/office/drawing/2014/main" val="262174811"/>
                  </a:ext>
                </a:extLst>
              </a:tr>
              <a:tr h="43633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ly and radiographically diagnosed knee osteoarthritis (index knee specified at baseline).</a:t>
                      </a:r>
                      <a:endParaRPr lang="ja-JP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or arthroplasty or osteotomy of the index knee, or planned surgery during follow‑up.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extLst>
                  <a:ext uri="{0D108BD9-81ED-4DB2-BD59-A6C34878D82A}">
                    <a16:rowId xmlns:a16="http://schemas.microsoft.com/office/drawing/2014/main" val="3954550220"/>
                  </a:ext>
                </a:extLst>
              </a:tr>
              <a:tr h="43633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sistent symptoms despite at least 3 months of standard conservative therapy (e.g., rest, NSAIDs/analgesics, physiotherapy).</a:t>
                      </a:r>
                      <a:endParaRPr lang="ja-JP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e infection (systemic or at the injection site) or skin breakdown over the index knee.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extLst>
                  <a:ext uri="{0D108BD9-81ED-4DB2-BD59-A6C34878D82A}">
                    <a16:rowId xmlns:a16="http://schemas.microsoft.com/office/drawing/2014/main" val="998951659"/>
                  </a:ext>
                </a:extLst>
              </a:tr>
              <a:tr h="2869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le to comply with study visits and procedures through week 52.</a:t>
                      </a:r>
                      <a:endParaRPr lang="ja-JP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e malignancy under treatment or recent diagnosis requiring therapy.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extLst>
                  <a:ext uri="{0D108BD9-81ED-4DB2-BD59-A6C34878D82A}">
                    <a16:rowId xmlns:a16="http://schemas.microsoft.com/office/drawing/2014/main" val="1918131293"/>
                  </a:ext>
                </a:extLst>
              </a:tr>
              <a:tr h="43633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vides written informed consent after adequate explanation.</a:t>
                      </a:r>
                      <a:endParaRPr lang="ja-JP" sz="12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rrent systemic immunosuppressants/biologics or high‑dose systemic steroids (per investigator judgment).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extLst>
                  <a:ext uri="{0D108BD9-81ED-4DB2-BD59-A6C34878D82A}">
                    <a16:rowId xmlns:a16="http://schemas.microsoft.com/office/drawing/2014/main" val="3976689208"/>
                  </a:ext>
                </a:extLst>
              </a:tr>
              <a:tr h="43633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agulopathy or therapeutic‑dose anticoagulation; concomitant dual antiplatelet therapy (≥ 2 agents).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extLst>
                  <a:ext uri="{0D108BD9-81ED-4DB2-BD59-A6C34878D82A}">
                    <a16:rowId xmlns:a16="http://schemas.microsoft.com/office/drawing/2014/main" val="3566335505"/>
                  </a:ext>
                </a:extLst>
              </a:tr>
              <a:tr h="2869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story of hypersensitivity to local anesthetics or study excipients.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extLst>
                  <a:ext uri="{0D108BD9-81ED-4DB2-BD59-A6C34878D82A}">
                    <a16:rowId xmlns:a16="http://schemas.microsoft.com/office/drawing/2014/main" val="2675476587"/>
                  </a:ext>
                </a:extLst>
              </a:tr>
              <a:tr h="58576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cent intra‑articular corticosteroid or hyaluronic acid in the index knee without protocol‑defined washout (per investigator judgment).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extLst>
                  <a:ext uri="{0D108BD9-81ED-4DB2-BD59-A6C34878D82A}">
                    <a16:rowId xmlns:a16="http://schemas.microsoft.com/office/drawing/2014/main" val="1740919682"/>
                  </a:ext>
                </a:extLst>
              </a:tr>
              <a:tr h="2869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gnancy or lactation, or planning pregnancy during the study period.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extLst>
                  <a:ext uri="{0D108BD9-81ED-4DB2-BD59-A6C34878D82A}">
                    <a16:rowId xmlns:a16="http://schemas.microsoft.com/office/drawing/2014/main" val="4270378225"/>
                  </a:ext>
                </a:extLst>
              </a:tr>
              <a:tr h="58576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controlled comorbidities (e.g., unstable cardiac disease, severe hepatic/renal insufficiency, uncontrolled diabetes or hypertension).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157" marR="53157" marT="0" marB="0"/>
                </a:tc>
                <a:extLst>
                  <a:ext uri="{0D108BD9-81ED-4DB2-BD59-A6C34878D82A}">
                    <a16:rowId xmlns:a16="http://schemas.microsoft.com/office/drawing/2014/main" val="2838542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799752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FE08860-6466-E8EB-E3B2-C9CE4EAF7D4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E0CCA757-C478-11A2-5915-F80F5CB3D5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5971300"/>
              </p:ext>
            </p:extLst>
          </p:nvPr>
        </p:nvGraphicFramePr>
        <p:xfrm>
          <a:off x="3282929" y="1778768"/>
          <a:ext cx="4229098" cy="898525"/>
        </p:xfrm>
        <a:graphic>
          <a:graphicData uri="http://schemas.openxmlformats.org/drawingml/2006/table">
            <a:tbl>
              <a:tblPr/>
              <a:tblGrid>
                <a:gridCol w="1980718">
                  <a:extLst>
                    <a:ext uri="{9D8B030D-6E8A-4147-A177-3AD203B41FA5}">
                      <a16:colId xmlns:a16="http://schemas.microsoft.com/office/drawing/2014/main" val="1206587119"/>
                    </a:ext>
                  </a:extLst>
                </a:gridCol>
                <a:gridCol w="374730">
                  <a:extLst>
                    <a:ext uri="{9D8B030D-6E8A-4147-A177-3AD203B41FA5}">
                      <a16:colId xmlns:a16="http://schemas.microsoft.com/office/drawing/2014/main" val="3462564955"/>
                    </a:ext>
                  </a:extLst>
                </a:gridCol>
                <a:gridCol w="374730">
                  <a:extLst>
                    <a:ext uri="{9D8B030D-6E8A-4147-A177-3AD203B41FA5}">
                      <a16:colId xmlns:a16="http://schemas.microsoft.com/office/drawing/2014/main" val="851892972"/>
                    </a:ext>
                  </a:extLst>
                </a:gridCol>
                <a:gridCol w="374730">
                  <a:extLst>
                    <a:ext uri="{9D8B030D-6E8A-4147-A177-3AD203B41FA5}">
                      <a16:colId xmlns:a16="http://schemas.microsoft.com/office/drawing/2014/main" val="3755744365"/>
                    </a:ext>
                  </a:extLst>
                </a:gridCol>
                <a:gridCol w="374730">
                  <a:extLst>
                    <a:ext uri="{9D8B030D-6E8A-4147-A177-3AD203B41FA5}">
                      <a16:colId xmlns:a16="http://schemas.microsoft.com/office/drawing/2014/main" val="3759686960"/>
                    </a:ext>
                  </a:extLst>
                </a:gridCol>
                <a:gridCol w="374730">
                  <a:extLst>
                    <a:ext uri="{9D8B030D-6E8A-4147-A177-3AD203B41FA5}">
                      <a16:colId xmlns:a16="http://schemas.microsoft.com/office/drawing/2014/main" val="1109433628"/>
                    </a:ext>
                  </a:extLst>
                </a:gridCol>
                <a:gridCol w="374730">
                  <a:extLst>
                    <a:ext uri="{9D8B030D-6E8A-4147-A177-3AD203B41FA5}">
                      <a16:colId xmlns:a16="http://schemas.microsoft.com/office/drawing/2014/main" val="2103271269"/>
                    </a:ext>
                  </a:extLst>
                </a:gridCol>
              </a:tblGrid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imal No.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Days after implantation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95349718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481752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4.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3.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4.6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4.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4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4.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3900149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2.6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2.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3.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3.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3.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4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4924762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3.6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2.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3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2.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2.6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3.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3045781"/>
                  </a:ext>
                </a:extLst>
              </a:tr>
            </a:tbl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FE2B6AD-B737-636D-6C5D-E5F6E61C2101}"/>
              </a:ext>
            </a:extLst>
          </p:cNvPr>
          <p:cNvSpPr txBox="1"/>
          <p:nvPr/>
        </p:nvSpPr>
        <p:spPr>
          <a:xfrm>
            <a:off x="2933607" y="2975041"/>
            <a:ext cx="7184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sz="12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3. Mini‑pig body weight trajectories until Day 31 (unit: kg).</a:t>
            </a:r>
          </a:p>
        </p:txBody>
      </p:sp>
    </p:spTree>
    <p:extLst>
      <p:ext uri="{BB962C8B-B14F-4D97-AF65-F5344CB8AC3E}">
        <p14:creationId xmlns:p14="http://schemas.microsoft.com/office/powerpoint/2010/main" val="10126801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F01A56A1-6F7C-538D-CEBD-17A1A584DD9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64234557"/>
              </p:ext>
            </p:extLst>
          </p:nvPr>
        </p:nvGraphicFramePr>
        <p:xfrm>
          <a:off x="648608" y="900589"/>
          <a:ext cx="9588498" cy="2259876"/>
        </p:xfrm>
        <a:graphic>
          <a:graphicData uri="http://schemas.openxmlformats.org/drawingml/2006/table">
            <a:tbl>
              <a:tblPr/>
              <a:tblGrid>
                <a:gridCol w="1765798">
                  <a:extLst>
                    <a:ext uri="{9D8B030D-6E8A-4147-A177-3AD203B41FA5}">
                      <a16:colId xmlns:a16="http://schemas.microsoft.com/office/drawing/2014/main" val="4222897201"/>
                    </a:ext>
                  </a:extLst>
                </a:gridCol>
                <a:gridCol w="1209188">
                  <a:extLst>
                    <a:ext uri="{9D8B030D-6E8A-4147-A177-3AD203B41FA5}">
                      <a16:colId xmlns:a16="http://schemas.microsoft.com/office/drawing/2014/main" val="2287705810"/>
                    </a:ext>
                  </a:extLst>
                </a:gridCol>
                <a:gridCol w="551126">
                  <a:extLst>
                    <a:ext uri="{9D8B030D-6E8A-4147-A177-3AD203B41FA5}">
                      <a16:colId xmlns:a16="http://schemas.microsoft.com/office/drawing/2014/main" val="3766683477"/>
                    </a:ext>
                  </a:extLst>
                </a:gridCol>
                <a:gridCol w="551126">
                  <a:extLst>
                    <a:ext uri="{9D8B030D-6E8A-4147-A177-3AD203B41FA5}">
                      <a16:colId xmlns:a16="http://schemas.microsoft.com/office/drawing/2014/main" val="268115463"/>
                    </a:ext>
                  </a:extLst>
                </a:gridCol>
                <a:gridCol w="551126">
                  <a:extLst>
                    <a:ext uri="{9D8B030D-6E8A-4147-A177-3AD203B41FA5}">
                      <a16:colId xmlns:a16="http://schemas.microsoft.com/office/drawing/2014/main" val="734557689"/>
                    </a:ext>
                  </a:extLst>
                </a:gridCol>
                <a:gridCol w="551126">
                  <a:extLst>
                    <a:ext uri="{9D8B030D-6E8A-4147-A177-3AD203B41FA5}">
                      <a16:colId xmlns:a16="http://schemas.microsoft.com/office/drawing/2014/main" val="3720961915"/>
                    </a:ext>
                  </a:extLst>
                </a:gridCol>
                <a:gridCol w="551126">
                  <a:extLst>
                    <a:ext uri="{9D8B030D-6E8A-4147-A177-3AD203B41FA5}">
                      <a16:colId xmlns:a16="http://schemas.microsoft.com/office/drawing/2014/main" val="3152795086"/>
                    </a:ext>
                  </a:extLst>
                </a:gridCol>
                <a:gridCol w="551126">
                  <a:extLst>
                    <a:ext uri="{9D8B030D-6E8A-4147-A177-3AD203B41FA5}">
                      <a16:colId xmlns:a16="http://schemas.microsoft.com/office/drawing/2014/main" val="4054568020"/>
                    </a:ext>
                  </a:extLst>
                </a:gridCol>
                <a:gridCol w="551126">
                  <a:extLst>
                    <a:ext uri="{9D8B030D-6E8A-4147-A177-3AD203B41FA5}">
                      <a16:colId xmlns:a16="http://schemas.microsoft.com/office/drawing/2014/main" val="2007943308"/>
                    </a:ext>
                  </a:extLst>
                </a:gridCol>
                <a:gridCol w="551126">
                  <a:extLst>
                    <a:ext uri="{9D8B030D-6E8A-4147-A177-3AD203B41FA5}">
                      <a16:colId xmlns:a16="http://schemas.microsoft.com/office/drawing/2014/main" val="1136372135"/>
                    </a:ext>
                  </a:extLst>
                </a:gridCol>
                <a:gridCol w="551126">
                  <a:extLst>
                    <a:ext uri="{9D8B030D-6E8A-4147-A177-3AD203B41FA5}">
                      <a16:colId xmlns:a16="http://schemas.microsoft.com/office/drawing/2014/main" val="1466572815"/>
                    </a:ext>
                  </a:extLst>
                </a:gridCol>
                <a:gridCol w="551126">
                  <a:extLst>
                    <a:ext uri="{9D8B030D-6E8A-4147-A177-3AD203B41FA5}">
                      <a16:colId xmlns:a16="http://schemas.microsoft.com/office/drawing/2014/main" val="3020430386"/>
                    </a:ext>
                  </a:extLst>
                </a:gridCol>
                <a:gridCol w="551126">
                  <a:extLst>
                    <a:ext uri="{9D8B030D-6E8A-4147-A177-3AD203B41FA5}">
                      <a16:colId xmlns:a16="http://schemas.microsoft.com/office/drawing/2014/main" val="3972286162"/>
                    </a:ext>
                  </a:extLst>
                </a:gridCol>
                <a:gridCol w="551126">
                  <a:extLst>
                    <a:ext uri="{9D8B030D-6E8A-4147-A177-3AD203B41FA5}">
                      <a16:colId xmlns:a16="http://schemas.microsoft.com/office/drawing/2014/main" val="1584897224"/>
                    </a:ext>
                  </a:extLst>
                </a:gridCol>
              </a:tblGrid>
              <a:tr h="17970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nimal No.</a:t>
                      </a: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Body weights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Brain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ituitary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ubmandibular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hyroids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ungs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Heart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11322370"/>
                  </a:ext>
                </a:extLst>
              </a:tr>
              <a:tr h="179705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kg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%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mg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mg%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%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mg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mg%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%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%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1111070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4.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1.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2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3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7.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73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34.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3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22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3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5329470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4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9.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2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2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6.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38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35.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4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68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5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62788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3.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1.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2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5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7.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91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58.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4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35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4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2318785"/>
                  </a:ext>
                </a:extLst>
              </a:tr>
              <a:tr h="103890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1529410"/>
                  </a:ext>
                </a:extLst>
              </a:tr>
              <a:tr h="168910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8417598"/>
                  </a:ext>
                </a:extLst>
              </a:tr>
              <a:tr h="17970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nimal No.</a:t>
                      </a: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iver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Kidneys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ancreas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drenals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Ovaries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Uterus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357411"/>
                  </a:ext>
                </a:extLst>
              </a:tr>
              <a:tr h="179705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%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%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%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mg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mg%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mg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mg%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g%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9368498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31.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5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40.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4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1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1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2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.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92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8.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90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5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234739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66.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3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12.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3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6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1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57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.6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27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5.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80.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8594555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25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2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63.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4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9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1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77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.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83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0.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66.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5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5935770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DE88455-67DF-0A5C-390A-61F45C28CB54}"/>
              </a:ext>
            </a:extLst>
          </p:cNvPr>
          <p:cNvSpPr txBox="1"/>
          <p:nvPr/>
        </p:nvSpPr>
        <p:spPr>
          <a:xfrm>
            <a:off x="648608" y="3559036"/>
            <a:ext cx="7184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sz="12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4. Mini‑pig relative organ weights at necropsy (Day 31).</a:t>
            </a:r>
          </a:p>
        </p:txBody>
      </p:sp>
    </p:spTree>
    <p:extLst>
      <p:ext uri="{BB962C8B-B14F-4D97-AF65-F5344CB8AC3E}">
        <p14:creationId xmlns:p14="http://schemas.microsoft.com/office/powerpoint/2010/main" val="36682688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09852EB9-C9AB-9C9B-9776-C4308FE847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3650009"/>
              </p:ext>
            </p:extLst>
          </p:nvPr>
        </p:nvGraphicFramePr>
        <p:xfrm>
          <a:off x="381000" y="458994"/>
          <a:ext cx="10515600" cy="1128324"/>
        </p:xfrm>
        <a:graphic>
          <a:graphicData uri="http://schemas.openxmlformats.org/drawingml/2006/table">
            <a:tbl>
              <a:tblPr/>
              <a:tblGrid>
                <a:gridCol w="1098645">
                  <a:extLst>
                    <a:ext uri="{9D8B030D-6E8A-4147-A177-3AD203B41FA5}">
                      <a16:colId xmlns:a16="http://schemas.microsoft.com/office/drawing/2014/main" val="222812570"/>
                    </a:ext>
                  </a:extLst>
                </a:gridCol>
                <a:gridCol w="724381">
                  <a:extLst>
                    <a:ext uri="{9D8B030D-6E8A-4147-A177-3AD203B41FA5}">
                      <a16:colId xmlns:a16="http://schemas.microsoft.com/office/drawing/2014/main" val="280580004"/>
                    </a:ext>
                  </a:extLst>
                </a:gridCol>
                <a:gridCol w="724381">
                  <a:extLst>
                    <a:ext uri="{9D8B030D-6E8A-4147-A177-3AD203B41FA5}">
                      <a16:colId xmlns:a16="http://schemas.microsoft.com/office/drawing/2014/main" val="3567027752"/>
                    </a:ext>
                  </a:extLst>
                </a:gridCol>
                <a:gridCol w="724381">
                  <a:extLst>
                    <a:ext uri="{9D8B030D-6E8A-4147-A177-3AD203B41FA5}">
                      <a16:colId xmlns:a16="http://schemas.microsoft.com/office/drawing/2014/main" val="1348960556"/>
                    </a:ext>
                  </a:extLst>
                </a:gridCol>
                <a:gridCol w="603651">
                  <a:extLst>
                    <a:ext uri="{9D8B030D-6E8A-4147-A177-3AD203B41FA5}">
                      <a16:colId xmlns:a16="http://schemas.microsoft.com/office/drawing/2014/main" val="1314271996"/>
                    </a:ext>
                  </a:extLst>
                </a:gridCol>
                <a:gridCol w="603651">
                  <a:extLst>
                    <a:ext uri="{9D8B030D-6E8A-4147-A177-3AD203B41FA5}">
                      <a16:colId xmlns:a16="http://schemas.microsoft.com/office/drawing/2014/main" val="711926925"/>
                    </a:ext>
                  </a:extLst>
                </a:gridCol>
                <a:gridCol w="603651">
                  <a:extLst>
                    <a:ext uri="{9D8B030D-6E8A-4147-A177-3AD203B41FA5}">
                      <a16:colId xmlns:a16="http://schemas.microsoft.com/office/drawing/2014/main" val="2155600277"/>
                    </a:ext>
                  </a:extLst>
                </a:gridCol>
                <a:gridCol w="603651">
                  <a:extLst>
                    <a:ext uri="{9D8B030D-6E8A-4147-A177-3AD203B41FA5}">
                      <a16:colId xmlns:a16="http://schemas.microsoft.com/office/drawing/2014/main" val="3061094306"/>
                    </a:ext>
                  </a:extLst>
                </a:gridCol>
                <a:gridCol w="603651">
                  <a:extLst>
                    <a:ext uri="{9D8B030D-6E8A-4147-A177-3AD203B41FA5}">
                      <a16:colId xmlns:a16="http://schemas.microsoft.com/office/drawing/2014/main" val="2329603956"/>
                    </a:ext>
                  </a:extLst>
                </a:gridCol>
                <a:gridCol w="603651">
                  <a:extLst>
                    <a:ext uri="{9D8B030D-6E8A-4147-A177-3AD203B41FA5}">
                      <a16:colId xmlns:a16="http://schemas.microsoft.com/office/drawing/2014/main" val="2605611474"/>
                    </a:ext>
                  </a:extLst>
                </a:gridCol>
                <a:gridCol w="603651">
                  <a:extLst>
                    <a:ext uri="{9D8B030D-6E8A-4147-A177-3AD203B41FA5}">
                      <a16:colId xmlns:a16="http://schemas.microsoft.com/office/drawing/2014/main" val="4258718448"/>
                    </a:ext>
                  </a:extLst>
                </a:gridCol>
                <a:gridCol w="603651">
                  <a:extLst>
                    <a:ext uri="{9D8B030D-6E8A-4147-A177-3AD203B41FA5}">
                      <a16:colId xmlns:a16="http://schemas.microsoft.com/office/drawing/2014/main" val="2854868300"/>
                    </a:ext>
                  </a:extLst>
                </a:gridCol>
                <a:gridCol w="603651">
                  <a:extLst>
                    <a:ext uri="{9D8B030D-6E8A-4147-A177-3AD203B41FA5}">
                      <a16:colId xmlns:a16="http://schemas.microsoft.com/office/drawing/2014/main" val="3922190406"/>
                    </a:ext>
                  </a:extLst>
                </a:gridCol>
                <a:gridCol w="603651">
                  <a:extLst>
                    <a:ext uri="{9D8B030D-6E8A-4147-A177-3AD203B41FA5}">
                      <a16:colId xmlns:a16="http://schemas.microsoft.com/office/drawing/2014/main" val="1738439558"/>
                    </a:ext>
                  </a:extLst>
                </a:gridCol>
                <a:gridCol w="603651">
                  <a:extLst>
                    <a:ext uri="{9D8B030D-6E8A-4147-A177-3AD203B41FA5}">
                      <a16:colId xmlns:a16="http://schemas.microsoft.com/office/drawing/2014/main" val="100545423"/>
                    </a:ext>
                  </a:extLst>
                </a:gridCol>
                <a:gridCol w="603651">
                  <a:extLst>
                    <a:ext uri="{9D8B030D-6E8A-4147-A177-3AD203B41FA5}">
                      <a16:colId xmlns:a16="http://schemas.microsoft.com/office/drawing/2014/main" val="3141116862"/>
                    </a:ext>
                  </a:extLst>
                </a:gridCol>
              </a:tblGrid>
              <a:tr h="17083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nimal No.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UV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.G.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K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l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6435242"/>
                  </a:ext>
                </a:extLst>
              </a:tr>
              <a:tr h="170833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L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Eq/L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Eq/L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Eq/L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2821723"/>
                  </a:ext>
                </a:extLst>
              </a:tr>
              <a:tr h="17083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1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2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3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1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2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3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1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2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3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1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2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3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1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2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3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3928614"/>
                  </a:ext>
                </a:extLst>
              </a:tr>
              <a:tr h="1708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66.0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33.0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19.1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013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030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007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4.7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4.8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9.1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36.6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96.8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6.0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8.2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2.5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3.1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6649934"/>
                  </a:ext>
                </a:extLst>
              </a:tr>
              <a:tr h="1708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29.6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73.5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50.4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024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020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022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23.1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1.6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19.6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01.1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59.9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35.6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32.3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9.8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30.1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5612035"/>
                  </a:ext>
                </a:extLst>
              </a:tr>
              <a:tr h="1708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26.1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40.1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77.0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022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028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021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43.5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20.0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1.5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06.7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40.6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20.1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36.6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25.7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16.5 </a:t>
                      </a:r>
                    </a:p>
                  </a:txBody>
                  <a:tcPr marL="5174" marR="5174" marT="51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6919435"/>
                  </a:ext>
                </a:extLst>
              </a:tr>
            </a:tbl>
          </a:graphicData>
        </a:graphic>
      </p:graphicFrame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3FA6A4B3-EFBE-683A-FD02-B6B4962FED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40361448"/>
              </p:ext>
            </p:extLst>
          </p:nvPr>
        </p:nvGraphicFramePr>
        <p:xfrm>
          <a:off x="381000" y="1667502"/>
          <a:ext cx="7251700" cy="1129938"/>
        </p:xfrm>
        <a:graphic>
          <a:graphicData uri="http://schemas.openxmlformats.org/drawingml/2006/table">
            <a:tbl>
              <a:tblPr/>
              <a:tblGrid>
                <a:gridCol w="1155700">
                  <a:extLst>
                    <a:ext uri="{9D8B030D-6E8A-4147-A177-3AD203B41FA5}">
                      <a16:colId xmlns:a16="http://schemas.microsoft.com/office/drawing/2014/main" val="1364095644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3847586434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1456637510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642640988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623348647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104464748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591089114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544209867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4256126217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537215855"/>
                    </a:ext>
                  </a:extLst>
                </a:gridCol>
              </a:tblGrid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nimal No.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K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l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0027966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Eq/day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Eq/day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Eq/day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595310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9647473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8.9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4.4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9.6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45.6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9.1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7.8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2.7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2.2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3.9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9908135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9.8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0.8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7.7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46.7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23.6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53.2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6.5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4.9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4.6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3893570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18.5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4.8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3.3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70.7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29.9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71.0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12.8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7.8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0.5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0235478"/>
                  </a:ext>
                </a:extLst>
              </a:tr>
            </a:tbl>
          </a:graphicData>
        </a:graphic>
      </p:graphicFrame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290960E6-4819-5D5A-9690-0F87CB376A2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3229397"/>
              </p:ext>
            </p:extLst>
          </p:nvPr>
        </p:nvGraphicFramePr>
        <p:xfrm>
          <a:off x="373980" y="2929242"/>
          <a:ext cx="9156701" cy="1678578"/>
        </p:xfrm>
        <a:graphic>
          <a:graphicData uri="http://schemas.openxmlformats.org/drawingml/2006/table">
            <a:tbl>
              <a:tblPr/>
              <a:tblGrid>
                <a:gridCol w="1837109">
                  <a:extLst>
                    <a:ext uri="{9D8B030D-6E8A-4147-A177-3AD203B41FA5}">
                      <a16:colId xmlns:a16="http://schemas.microsoft.com/office/drawing/2014/main" val="47205887"/>
                    </a:ext>
                  </a:extLst>
                </a:gridCol>
                <a:gridCol w="700812">
                  <a:extLst>
                    <a:ext uri="{9D8B030D-6E8A-4147-A177-3AD203B41FA5}">
                      <a16:colId xmlns:a16="http://schemas.microsoft.com/office/drawing/2014/main" val="371096725"/>
                    </a:ext>
                  </a:extLst>
                </a:gridCol>
                <a:gridCol w="700812">
                  <a:extLst>
                    <a:ext uri="{9D8B030D-6E8A-4147-A177-3AD203B41FA5}">
                      <a16:colId xmlns:a16="http://schemas.microsoft.com/office/drawing/2014/main" val="1569411872"/>
                    </a:ext>
                  </a:extLst>
                </a:gridCol>
                <a:gridCol w="700812">
                  <a:extLst>
                    <a:ext uri="{9D8B030D-6E8A-4147-A177-3AD203B41FA5}">
                      <a16:colId xmlns:a16="http://schemas.microsoft.com/office/drawing/2014/main" val="2471710916"/>
                    </a:ext>
                  </a:extLst>
                </a:gridCol>
                <a:gridCol w="579684">
                  <a:extLst>
                    <a:ext uri="{9D8B030D-6E8A-4147-A177-3AD203B41FA5}">
                      <a16:colId xmlns:a16="http://schemas.microsoft.com/office/drawing/2014/main" val="55765322"/>
                    </a:ext>
                  </a:extLst>
                </a:gridCol>
                <a:gridCol w="579684">
                  <a:extLst>
                    <a:ext uri="{9D8B030D-6E8A-4147-A177-3AD203B41FA5}">
                      <a16:colId xmlns:a16="http://schemas.microsoft.com/office/drawing/2014/main" val="3284979022"/>
                    </a:ext>
                  </a:extLst>
                </a:gridCol>
                <a:gridCol w="579684">
                  <a:extLst>
                    <a:ext uri="{9D8B030D-6E8A-4147-A177-3AD203B41FA5}">
                      <a16:colId xmlns:a16="http://schemas.microsoft.com/office/drawing/2014/main" val="477534933"/>
                    </a:ext>
                  </a:extLst>
                </a:gridCol>
                <a:gridCol w="579684">
                  <a:extLst>
                    <a:ext uri="{9D8B030D-6E8A-4147-A177-3AD203B41FA5}">
                      <a16:colId xmlns:a16="http://schemas.microsoft.com/office/drawing/2014/main" val="299312570"/>
                    </a:ext>
                  </a:extLst>
                </a:gridCol>
                <a:gridCol w="579684">
                  <a:extLst>
                    <a:ext uri="{9D8B030D-6E8A-4147-A177-3AD203B41FA5}">
                      <a16:colId xmlns:a16="http://schemas.microsoft.com/office/drawing/2014/main" val="3900305406"/>
                    </a:ext>
                  </a:extLst>
                </a:gridCol>
                <a:gridCol w="579684">
                  <a:extLst>
                    <a:ext uri="{9D8B030D-6E8A-4147-A177-3AD203B41FA5}">
                      <a16:colId xmlns:a16="http://schemas.microsoft.com/office/drawing/2014/main" val="1246587106"/>
                    </a:ext>
                  </a:extLst>
                </a:gridCol>
                <a:gridCol w="579684">
                  <a:extLst>
                    <a:ext uri="{9D8B030D-6E8A-4147-A177-3AD203B41FA5}">
                      <a16:colId xmlns:a16="http://schemas.microsoft.com/office/drawing/2014/main" val="3924719074"/>
                    </a:ext>
                  </a:extLst>
                </a:gridCol>
                <a:gridCol w="579684">
                  <a:extLst>
                    <a:ext uri="{9D8B030D-6E8A-4147-A177-3AD203B41FA5}">
                      <a16:colId xmlns:a16="http://schemas.microsoft.com/office/drawing/2014/main" val="1193244357"/>
                    </a:ext>
                  </a:extLst>
                </a:gridCol>
                <a:gridCol w="579684">
                  <a:extLst>
                    <a:ext uri="{9D8B030D-6E8A-4147-A177-3AD203B41FA5}">
                      <a16:colId xmlns:a16="http://schemas.microsoft.com/office/drawing/2014/main" val="3013255217"/>
                    </a:ext>
                  </a:extLst>
                </a:gridCol>
              </a:tblGrid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nimal No.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 gridSpan="3"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lor</a:t>
                      </a:r>
                    </a:p>
                  </a:txBody>
                  <a:tcPr marL="5443" marR="5443" marT="5443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gridSpan="3"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H</a:t>
                      </a:r>
                    </a:p>
                  </a:txBody>
                  <a:tcPr marL="5443" marR="5443" marT="5443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gridSpan="3"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otein</a:t>
                      </a:r>
                    </a:p>
                  </a:txBody>
                  <a:tcPr marL="5443" marR="5443" marT="5443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gridSpan="3"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Glucose</a:t>
                      </a:r>
                    </a:p>
                  </a:txBody>
                  <a:tcPr marL="5443" marR="5443" marT="5443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8417462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8822545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8335796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ight yellow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ight yellow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ight yellow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.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0750258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ight yellow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ight yellow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ight yellow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.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815332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ight yellow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ight yellow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ight yellow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≧</a:t>
                      </a:r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.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.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8413287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CE93B1B-D2A3-A7DB-551B-720D6A9D9A07}"/>
              </a:ext>
            </a:extLst>
          </p:cNvPr>
          <p:cNvSpPr txBox="1"/>
          <p:nvPr/>
        </p:nvSpPr>
        <p:spPr>
          <a:xfrm>
            <a:off x="381000" y="4774999"/>
            <a:ext cx="95232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5(A). Urinalysis (mini‑pig).</a:t>
            </a:r>
          </a:p>
          <a:p>
            <a:pPr algn="l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</a:t>
            </a:r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: −, negative; ±, trace; +, 30 mg/dL; ++, 100 mg/dL; +++, ≥300 mg/dL.</a:t>
            </a:r>
          </a:p>
          <a:p>
            <a:pPr algn="l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</a:t>
            </a:r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cose: −, negative; +, 100 mg/dL; ++, 250 mg/dL; +++, 500 mg/dL; ++++, 1000 mg/dL.</a:t>
            </a:r>
          </a:p>
          <a:p>
            <a:pPr algn="l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</a:t>
            </a:r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‑1: before liposuction; Pre‑2: before implantation; Pre‑3: before necropsy.</a:t>
            </a:r>
          </a:p>
        </p:txBody>
      </p:sp>
    </p:spTree>
    <p:extLst>
      <p:ext uri="{BB962C8B-B14F-4D97-AF65-F5344CB8AC3E}">
        <p14:creationId xmlns:p14="http://schemas.microsoft.com/office/powerpoint/2010/main" val="31127217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338438ED-5D83-3835-2A08-429DD08F88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8989089"/>
              </p:ext>
            </p:extLst>
          </p:nvPr>
        </p:nvGraphicFramePr>
        <p:xfrm>
          <a:off x="594152" y="302723"/>
          <a:ext cx="10375900" cy="1129938"/>
        </p:xfrm>
        <a:graphic>
          <a:graphicData uri="http://schemas.openxmlformats.org/drawingml/2006/table">
            <a:tbl>
              <a:tblPr/>
              <a:tblGrid>
                <a:gridCol w="850900">
                  <a:extLst>
                    <a:ext uri="{9D8B030D-6E8A-4147-A177-3AD203B41FA5}">
                      <a16:colId xmlns:a16="http://schemas.microsoft.com/office/drawing/2014/main" val="397613343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143449604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25360899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041277007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710062281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588499766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681417776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1196773703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680218006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703230762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787255777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4138381106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019535795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151390724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478895105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297353905"/>
                    </a:ext>
                  </a:extLst>
                </a:gridCol>
              </a:tblGrid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imal No.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BC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HGB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HCT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CV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CH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8953000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^4/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/dL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%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L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g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485240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0200508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6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4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3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6.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0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6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5.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6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7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8.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84139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4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8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3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3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1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3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2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3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3.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.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8820631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1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9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4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1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1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4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0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3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3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7715774"/>
                  </a:ext>
                </a:extLst>
              </a:tr>
            </a:tbl>
          </a:graphicData>
        </a:graphic>
      </p:graphicFrame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C4739A95-6B3F-7F06-59EE-F6EAF634CCD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2658739"/>
              </p:ext>
            </p:extLst>
          </p:nvPr>
        </p:nvGraphicFramePr>
        <p:xfrm>
          <a:off x="594152" y="1544669"/>
          <a:ext cx="10107386" cy="1129938"/>
        </p:xfrm>
        <a:graphic>
          <a:graphicData uri="http://schemas.openxmlformats.org/drawingml/2006/table">
            <a:tbl>
              <a:tblPr/>
              <a:tblGrid>
                <a:gridCol w="850900">
                  <a:extLst>
                    <a:ext uri="{9D8B030D-6E8A-4147-A177-3AD203B41FA5}">
                      <a16:colId xmlns:a16="http://schemas.microsoft.com/office/drawing/2014/main" val="921871609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542820521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722182770"/>
                    </a:ext>
                  </a:extLst>
                </a:gridCol>
                <a:gridCol w="366486">
                  <a:extLst>
                    <a:ext uri="{9D8B030D-6E8A-4147-A177-3AD203B41FA5}">
                      <a16:colId xmlns:a16="http://schemas.microsoft.com/office/drawing/2014/main" val="1830169473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009667706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4073908930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1461672565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520501888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201764109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905427728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006085535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260205119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1235824187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712920573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1957212260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791519505"/>
                    </a:ext>
                  </a:extLst>
                </a:gridCol>
              </a:tblGrid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imal No.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CHC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LT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T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T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T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0016075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/dL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/dL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^4/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%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ec.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63836173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491535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2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1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2.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3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3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4..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4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0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9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5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92810788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1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1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2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5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0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4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7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7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6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4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4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4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5517128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2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1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1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9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8.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8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5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3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7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4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5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4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0032424"/>
                  </a:ext>
                </a:extLst>
              </a:tr>
            </a:tbl>
          </a:graphicData>
        </a:graphic>
      </p:graphicFrame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B6F24EAC-2BAF-C7CE-623E-DD7B3B05601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55396428"/>
              </p:ext>
            </p:extLst>
          </p:nvPr>
        </p:nvGraphicFramePr>
        <p:xfrm>
          <a:off x="594152" y="2779791"/>
          <a:ext cx="10375900" cy="1129938"/>
        </p:xfrm>
        <a:graphic>
          <a:graphicData uri="http://schemas.openxmlformats.org/drawingml/2006/table">
            <a:tbl>
              <a:tblPr/>
              <a:tblGrid>
                <a:gridCol w="850900">
                  <a:extLst>
                    <a:ext uri="{9D8B030D-6E8A-4147-A177-3AD203B41FA5}">
                      <a16:colId xmlns:a16="http://schemas.microsoft.com/office/drawing/2014/main" val="4268421305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877716283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960352155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4114289233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1697457396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148276867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663214572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831724741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1589610386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000876608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204298084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48113502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455300479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1090233936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897862604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585725513"/>
                    </a:ext>
                  </a:extLst>
                </a:gridCol>
              </a:tblGrid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imal No.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PTT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bg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WBC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YMPH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EUT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7916729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ec.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f/dL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^2/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^2/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^2/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804903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7445332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46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88.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3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1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6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4.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1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6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2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5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4891051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14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08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1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9.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2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7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4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6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6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7297784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5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88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7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41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3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4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8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5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0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0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8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4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1952358"/>
                  </a:ext>
                </a:extLst>
              </a:tr>
            </a:tbl>
          </a:graphicData>
        </a:graphic>
      </p:graphicFrame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D128B4C7-C6FB-D9DE-1FA9-B2AA91552B7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25147951"/>
              </p:ext>
            </p:extLst>
          </p:nvPr>
        </p:nvGraphicFramePr>
        <p:xfrm>
          <a:off x="594152" y="4014913"/>
          <a:ext cx="10375900" cy="1129938"/>
        </p:xfrm>
        <a:graphic>
          <a:graphicData uri="http://schemas.openxmlformats.org/drawingml/2006/table">
            <a:tbl>
              <a:tblPr/>
              <a:tblGrid>
                <a:gridCol w="850900">
                  <a:extLst>
                    <a:ext uri="{9D8B030D-6E8A-4147-A177-3AD203B41FA5}">
                      <a16:colId xmlns:a16="http://schemas.microsoft.com/office/drawing/2014/main" val="3245638950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1236969501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226758335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611547008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465300667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1074390031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4251402394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144452004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7123247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428940892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446372362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683976875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536304713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210196334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561545329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1651833602"/>
                    </a:ext>
                  </a:extLst>
                </a:gridCol>
              </a:tblGrid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imal No.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EO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BASO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ONO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YMPH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EUT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2774237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^2/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^2/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^2/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%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%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9255291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4043454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5.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2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3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4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4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0127551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8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7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0.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2012871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1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1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6.5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5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1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1271701"/>
                  </a:ext>
                </a:extLst>
              </a:tr>
            </a:tbl>
          </a:graphicData>
        </a:graphic>
      </p:graphicFrame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0660AD93-1DBD-20F9-FC9F-92BADAE7E8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00958816"/>
              </p:ext>
            </p:extLst>
          </p:nvPr>
        </p:nvGraphicFramePr>
        <p:xfrm>
          <a:off x="594152" y="5250035"/>
          <a:ext cx="6565900" cy="1129938"/>
        </p:xfrm>
        <a:graphic>
          <a:graphicData uri="http://schemas.openxmlformats.org/drawingml/2006/table">
            <a:tbl>
              <a:tblPr/>
              <a:tblGrid>
                <a:gridCol w="850900">
                  <a:extLst>
                    <a:ext uri="{9D8B030D-6E8A-4147-A177-3AD203B41FA5}">
                      <a16:colId xmlns:a16="http://schemas.microsoft.com/office/drawing/2014/main" val="3073455078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4288548641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151610048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344615624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640434606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985996207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1569285879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01488090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464191494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3556273657"/>
                    </a:ext>
                  </a:extLst>
                </a:gridCol>
              </a:tblGrid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imal No.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EO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BASO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ONO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750077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%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%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%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9381862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8957765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4078201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.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6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7567839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2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7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.0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8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4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1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9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9357749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973064D-BB21-3B3A-E5F9-C576B44822A4}"/>
              </a:ext>
            </a:extLst>
          </p:cNvPr>
          <p:cNvSpPr txBox="1"/>
          <p:nvPr/>
        </p:nvSpPr>
        <p:spPr>
          <a:xfrm>
            <a:off x="7235117" y="5584171"/>
            <a:ext cx="402536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5(B). Hematology (mini‑pig).</a:t>
            </a:r>
          </a:p>
          <a:p>
            <a:pPr algn="l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</a:t>
            </a:r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‑1: before liposuction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</a:t>
            </a:r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‑2: befor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plantation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</a:t>
            </a:r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‑3: before necropsy</a:t>
            </a:r>
          </a:p>
        </p:txBody>
      </p:sp>
    </p:spTree>
    <p:extLst>
      <p:ext uri="{BB962C8B-B14F-4D97-AF65-F5344CB8AC3E}">
        <p14:creationId xmlns:p14="http://schemas.microsoft.com/office/powerpoint/2010/main" val="23105105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84CC5933-F076-5F02-55C0-85C4DE1C739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1146690"/>
              </p:ext>
            </p:extLst>
          </p:nvPr>
        </p:nvGraphicFramePr>
        <p:xfrm>
          <a:off x="312764" y="196918"/>
          <a:ext cx="10515594" cy="1128906"/>
        </p:xfrm>
        <a:graphic>
          <a:graphicData uri="http://schemas.openxmlformats.org/drawingml/2006/table">
            <a:tbl>
              <a:tblPr/>
              <a:tblGrid>
                <a:gridCol w="1291389">
                  <a:extLst>
                    <a:ext uri="{9D8B030D-6E8A-4147-A177-3AD203B41FA5}">
                      <a16:colId xmlns:a16="http://schemas.microsoft.com/office/drawing/2014/main" val="4066248164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71800361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700379327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587733633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658950221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805795501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202115764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863533288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4101219403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26141312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625399417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617522978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4199945352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136008121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4004634799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70301590"/>
                    </a:ext>
                  </a:extLst>
                </a:gridCol>
              </a:tblGrid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imal No.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ST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LT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LP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K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γ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T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1563884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U/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U/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U/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U/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U/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2607296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079748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8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9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8.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5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5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6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37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24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63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98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07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27.6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5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2.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6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9336264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0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1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0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6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0.6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2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13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57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55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37.6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04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37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7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5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6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4498635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8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8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0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1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7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28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56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62.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68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83.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92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6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1.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4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2228550"/>
                  </a:ext>
                </a:extLst>
              </a:tr>
            </a:tbl>
          </a:graphicData>
        </a:graphic>
      </p:graphicFrame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7EE3E1BE-7D55-47A1-648C-956704975C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3534752"/>
              </p:ext>
            </p:extLst>
          </p:nvPr>
        </p:nvGraphicFramePr>
        <p:xfrm>
          <a:off x="312764" y="1363801"/>
          <a:ext cx="10515594" cy="1128906"/>
        </p:xfrm>
        <a:graphic>
          <a:graphicData uri="http://schemas.openxmlformats.org/drawingml/2006/table">
            <a:tbl>
              <a:tblPr/>
              <a:tblGrid>
                <a:gridCol w="1291389">
                  <a:extLst>
                    <a:ext uri="{9D8B030D-6E8A-4147-A177-3AD203B41FA5}">
                      <a16:colId xmlns:a16="http://schemas.microsoft.com/office/drawing/2014/main" val="1610310021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231224173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116844435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019318408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520089461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245888560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639920420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111141000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097734506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585870257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807275765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4031952407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633972007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580702970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912462130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748072215"/>
                    </a:ext>
                  </a:extLst>
                </a:gridCol>
              </a:tblGrid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imal No.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D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P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lb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lb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α1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lb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011666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U/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/d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/d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%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%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0118184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6809350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93.6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79.6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52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.0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4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5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6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4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5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5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6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6.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25428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40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44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99.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1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9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8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6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4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4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0.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9.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1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1470523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58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81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11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3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0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0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8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7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6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2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2.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2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9555614"/>
                  </a:ext>
                </a:extLst>
              </a:tr>
            </a:tbl>
          </a:graphicData>
        </a:graphic>
      </p:graphicFrame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FAD037E6-B303-7008-3B39-38D4E30AF7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0681735"/>
              </p:ext>
            </p:extLst>
          </p:nvPr>
        </p:nvGraphicFramePr>
        <p:xfrm>
          <a:off x="312764" y="2530684"/>
          <a:ext cx="10515594" cy="1128906"/>
        </p:xfrm>
        <a:graphic>
          <a:graphicData uri="http://schemas.openxmlformats.org/drawingml/2006/table">
            <a:tbl>
              <a:tblPr/>
              <a:tblGrid>
                <a:gridCol w="1291389">
                  <a:extLst>
                    <a:ext uri="{9D8B030D-6E8A-4147-A177-3AD203B41FA5}">
                      <a16:colId xmlns:a16="http://schemas.microsoft.com/office/drawing/2014/main" val="2040935243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691978260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154578651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854278293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56741620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614470034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910270893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333503688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4227683182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202398951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430676589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304903666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36982682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233873161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4116959647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382782270"/>
                    </a:ext>
                  </a:extLst>
                </a:gridCol>
              </a:tblGrid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imal No.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α2 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lb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β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lb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γ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lb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/G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-Bi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2493503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%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%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%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g/d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073122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9810450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.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5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5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.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.6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.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3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2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2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8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8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8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1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1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8934177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5.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4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0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0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9.6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0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0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0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1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7352643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5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5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4.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.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8.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0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0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1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0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1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1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1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0177374"/>
                  </a:ext>
                </a:extLst>
              </a:tr>
            </a:tbl>
          </a:graphicData>
        </a:graphic>
      </p:graphicFrame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5EFE03DC-A762-1793-B8D9-E648DBDEFE2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6407712"/>
              </p:ext>
            </p:extLst>
          </p:nvPr>
        </p:nvGraphicFramePr>
        <p:xfrm>
          <a:off x="312764" y="3697567"/>
          <a:ext cx="10515594" cy="1128906"/>
        </p:xfrm>
        <a:graphic>
          <a:graphicData uri="http://schemas.openxmlformats.org/drawingml/2006/table">
            <a:tbl>
              <a:tblPr/>
              <a:tblGrid>
                <a:gridCol w="1291389">
                  <a:extLst>
                    <a:ext uri="{9D8B030D-6E8A-4147-A177-3AD203B41FA5}">
                      <a16:colId xmlns:a16="http://schemas.microsoft.com/office/drawing/2014/main" val="1535144553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811271029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547107861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4160755613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443179262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412667283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603656918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4225395667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974713815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347710381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221530282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597292758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826203631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415065999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4115039113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46403561"/>
                    </a:ext>
                  </a:extLst>
                </a:gridCol>
              </a:tblGrid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imal No.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UN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RE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lu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-Cho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G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880736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g/d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g/d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g/d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g/d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g/d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4691018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9727155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6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6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7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6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1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6.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9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2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2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9.6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5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0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7.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1428536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.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8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8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7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1.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5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4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1.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6.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9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2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8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7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4221249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6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6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8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8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3.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7.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1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5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6.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6.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9.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2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8522874"/>
                  </a:ext>
                </a:extLst>
              </a:tr>
            </a:tbl>
          </a:graphicData>
        </a:graphic>
      </p:graphicFrame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032C4097-2E47-ACDA-5F87-3BD931B91CA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0843801"/>
              </p:ext>
            </p:extLst>
          </p:nvPr>
        </p:nvGraphicFramePr>
        <p:xfrm>
          <a:off x="312764" y="4864450"/>
          <a:ext cx="10515594" cy="1128906"/>
        </p:xfrm>
        <a:graphic>
          <a:graphicData uri="http://schemas.openxmlformats.org/drawingml/2006/table">
            <a:tbl>
              <a:tblPr/>
              <a:tblGrid>
                <a:gridCol w="1291389">
                  <a:extLst>
                    <a:ext uri="{9D8B030D-6E8A-4147-A177-3AD203B41FA5}">
                      <a16:colId xmlns:a16="http://schemas.microsoft.com/office/drawing/2014/main" val="3963068041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763681876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900024067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720698964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933583200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483244146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857936136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2952740872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541154156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088442447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462294648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840136730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3286535629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494043073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4012555098"/>
                    </a:ext>
                  </a:extLst>
                </a:gridCol>
                <a:gridCol w="614947">
                  <a:extLst>
                    <a:ext uri="{9D8B030D-6E8A-4147-A177-3AD203B41FA5}">
                      <a16:colId xmlns:a16="http://schemas.microsoft.com/office/drawing/2014/main" val="1610180923"/>
                    </a:ext>
                  </a:extLst>
                </a:gridCol>
              </a:tblGrid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imal No.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a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K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a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P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6038682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Eq/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Eq/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Eq/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g/d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g/dL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4285620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e 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7393440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9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41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6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9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6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9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3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1.6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2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0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8642079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41.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5.6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5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.2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8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.3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4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0.6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2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.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.6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5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5669812"/>
                  </a:ext>
                </a:extLst>
              </a:tr>
              <a:tr h="1740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8.9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40.3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6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96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7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.78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3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3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2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4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.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7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.1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2 </a:t>
                      </a:r>
                    </a:p>
                  </a:txBody>
                  <a:tcPr marL="5271" marR="5271" marT="527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9604663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EE31800-25A5-8209-F479-0A9D55B0DCE8}"/>
              </a:ext>
            </a:extLst>
          </p:cNvPr>
          <p:cNvSpPr txBox="1"/>
          <p:nvPr/>
        </p:nvSpPr>
        <p:spPr>
          <a:xfrm>
            <a:off x="312764" y="6167286"/>
            <a:ext cx="103723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5(C). Serum biochemistry (mini‑pig).</a:t>
            </a:r>
          </a:p>
          <a:p>
            <a:pPr algn="l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</a:t>
            </a:r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‑1: before liposuction;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‑2: before implantation;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‑3: before necropsy.</a:t>
            </a:r>
          </a:p>
        </p:txBody>
      </p:sp>
    </p:spTree>
    <p:extLst>
      <p:ext uri="{BB962C8B-B14F-4D97-AF65-F5344CB8AC3E}">
        <p14:creationId xmlns:p14="http://schemas.microsoft.com/office/powerpoint/2010/main" val="133321241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8CC3E25-8365-C7C7-F394-41ACA0774CED}"/>
              </a:ext>
            </a:extLst>
          </p:cNvPr>
          <p:cNvSpPr txBox="1"/>
          <p:nvPr/>
        </p:nvSpPr>
        <p:spPr>
          <a:xfrm>
            <a:off x="524656" y="4751882"/>
            <a:ext cx="1035820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6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Quadratic mixed-effects analysis of longitudinal clinical outcomes.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-dependent changes were evaluated using linear mixed-effects models including both linear and quadratic time terms, with patient ID treated as a random intercept. Quadratic models were compared with linear-only models using likelihood ratio tests. Significant model comparison p-values indicate that inclusion of the quadratic term significantly improved model fit, supporting a non-linear temporal response pattern. For VAS and WOMAC outcomes, negative coefficients indicate improvement (score reduction). For KOOS outcomes, positive coefficients indicate improvement (score increase)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18901804-0DBC-78FF-37F6-71801EF0B2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0002556"/>
              </p:ext>
            </p:extLst>
          </p:nvPr>
        </p:nvGraphicFramePr>
        <p:xfrm>
          <a:off x="764612" y="637574"/>
          <a:ext cx="7292601" cy="3927768"/>
        </p:xfrm>
        <a:graphic>
          <a:graphicData uri="http://schemas.openxmlformats.org/drawingml/2006/table">
            <a:tbl>
              <a:tblPr/>
              <a:tblGrid>
                <a:gridCol w="1390011">
                  <a:extLst>
                    <a:ext uri="{9D8B030D-6E8A-4147-A177-3AD203B41FA5}">
                      <a16:colId xmlns:a16="http://schemas.microsoft.com/office/drawing/2014/main" val="1003557137"/>
                    </a:ext>
                  </a:extLst>
                </a:gridCol>
                <a:gridCol w="1218164">
                  <a:extLst>
                    <a:ext uri="{9D8B030D-6E8A-4147-A177-3AD203B41FA5}">
                      <a16:colId xmlns:a16="http://schemas.microsoft.com/office/drawing/2014/main" val="1079748322"/>
                    </a:ext>
                  </a:extLst>
                </a:gridCol>
                <a:gridCol w="1004341">
                  <a:extLst>
                    <a:ext uri="{9D8B030D-6E8A-4147-A177-3AD203B41FA5}">
                      <a16:colId xmlns:a16="http://schemas.microsoft.com/office/drawing/2014/main" val="1066298566"/>
                    </a:ext>
                  </a:extLst>
                </a:gridCol>
                <a:gridCol w="1424065">
                  <a:extLst>
                    <a:ext uri="{9D8B030D-6E8A-4147-A177-3AD203B41FA5}">
                      <a16:colId xmlns:a16="http://schemas.microsoft.com/office/drawing/2014/main" val="778900579"/>
                    </a:ext>
                  </a:extLst>
                </a:gridCol>
                <a:gridCol w="861935">
                  <a:extLst>
                    <a:ext uri="{9D8B030D-6E8A-4147-A177-3AD203B41FA5}">
                      <a16:colId xmlns:a16="http://schemas.microsoft.com/office/drawing/2014/main" val="4001542880"/>
                    </a:ext>
                  </a:extLst>
                </a:gridCol>
                <a:gridCol w="1394085">
                  <a:extLst>
                    <a:ext uri="{9D8B030D-6E8A-4147-A177-3AD203B41FA5}">
                      <a16:colId xmlns:a16="http://schemas.microsoft.com/office/drawing/2014/main" val="3132202365"/>
                    </a:ext>
                  </a:extLst>
                </a:gridCol>
              </a:tblGrid>
              <a:tr h="725223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come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near term (</a:t>
                      </a:r>
                      <a:r>
                        <a:rPr lang="el-GR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)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dratic term (</a:t>
                      </a:r>
                      <a:r>
                        <a:rPr lang="el-GR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)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mparison p-value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7472073"/>
                  </a:ext>
                </a:extLst>
              </a:tr>
              <a:tr h="29008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S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ja-JP" alt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48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0.026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9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9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4917255"/>
                  </a:ext>
                </a:extLst>
              </a:tr>
              <a:tr h="29008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OMAC Total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ja-JP" alt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2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0.006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7720246"/>
                  </a:ext>
                </a:extLst>
              </a:tr>
              <a:tr h="29008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OMAC Pain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ja-JP" alt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5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2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0.002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7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143073"/>
                  </a:ext>
                </a:extLst>
              </a:tr>
              <a:tr h="29277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OMAC Stiffness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ja-JP" alt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5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0.002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8303392"/>
                  </a:ext>
                </a:extLst>
              </a:tr>
              <a:tr h="29008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OMAC Function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ja-JP" alt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7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0.004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1867716"/>
                  </a:ext>
                </a:extLst>
              </a:tr>
              <a:tr h="29008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OS Total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1.142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ja-JP" alt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3360797"/>
                  </a:ext>
                </a:extLst>
              </a:tr>
              <a:tr h="29008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OS Pain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0.264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ja-JP" alt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1762182"/>
                  </a:ext>
                </a:extLst>
              </a:tr>
              <a:tr h="298965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OS Symptoms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0.155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ja-JP" alt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7906078"/>
                  </a:ext>
                </a:extLst>
              </a:tr>
              <a:tr h="29008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OS Sports/Rec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0.283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ja-JP" alt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344032"/>
                  </a:ext>
                </a:extLst>
              </a:tr>
              <a:tr h="29008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OS ADL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0.233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ja-JP" alt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086256"/>
                  </a:ext>
                </a:extLst>
              </a:tr>
              <a:tr h="290089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OS QOL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0.178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ja-JP" alt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72522" marR="72522" marT="36261" marB="362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1253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395927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58</TotalTime>
  <Words>2268</Words>
  <Application>Microsoft Office PowerPoint</Application>
  <PresentationFormat>ワイド画面</PresentationFormat>
  <Paragraphs>1274</Paragraphs>
  <Slides>8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3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usuke Harada</dc:creator>
  <cp:lastModifiedBy>satoshi sobajima</cp:lastModifiedBy>
  <cp:revision>63</cp:revision>
  <dcterms:created xsi:type="dcterms:W3CDTF">2025-01-16T05:32:17Z</dcterms:created>
  <dcterms:modified xsi:type="dcterms:W3CDTF">2026-03-01T07:26:12Z</dcterms:modified>
</cp:coreProperties>
</file>